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8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21883-9C39-4282-9329-F3BBA47931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09CE612-04FC-4FDC-A6B8-C8450B4FBD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8E3E85-040F-419A-83F1-4B036035F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3A41D0-2A41-4AF9-AF51-8693BF889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81AB24-920E-4493-91AF-1DA761637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45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C781E-4D83-4D82-9FE1-272A8C383F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8FE368-4AC5-475A-878F-06BAE7FFEB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E390FE-F9F1-475F-BB7D-E7D789F4A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387D5A-EA33-4508-B4AC-6C2DA8375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CDD78C-69BA-48A8-A66A-D1D217771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770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2DD55A-6AE7-4F55-8831-7118CA55D0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3D6C4F-EF76-47B8-83F7-C5162A0490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AF4AB9-5DFD-4E27-8145-0B819C040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F548D5-E548-44B9-B645-AD060EFDF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4C2AC-5708-489D-A861-7A240C3D1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613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D44C0-BE81-4256-8690-086A46D37D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18FEB5-3D6D-4B9D-9D2A-3997B8320C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6B78E-32C0-41EE-879B-C467D2952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036B0-BE83-4A52-8B7D-E9A084752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ECEF41-B8DB-4D5F-9252-B9DF53D9B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866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C38F9-C4CE-44E7-B86D-86EC032AC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221EEB-2DF8-42C2-AAD6-13FEBD6082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1F22C-2344-4854-9AB1-86B97DA1F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70AF3B-F85F-4B74-BCEB-C647904C9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924AB3-E255-4331-A99C-ADEC27D7E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507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DF1004-DCCC-4EDA-81DB-921FBFB4E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F0D33B-BA07-403C-B289-CAB29E0B68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0E6DFE-1509-4505-AB75-86AA21ED50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0DE166-C44E-42C6-A528-782552B47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F8C473-759F-47A2-9AF5-563179D1B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C309A3-1C17-4A0D-A857-DAFB9D0AF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087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F1117D-586B-4380-83DD-BEE1EF807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4F5444-7833-4BE9-807E-F5EC41E06B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E20CD9-4F33-4303-87B7-DE3A0D57B5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952FB0-DD41-4A18-9838-5F02962BEE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D7DC79-DDB5-4DAD-BFFA-44DE1C820B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C19E25-E4D9-4FC2-977C-EE6292099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630C2D-6257-4F69-A5F2-960B70884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E38937-6DCE-4971-A6C7-C1E72B3F7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267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D7AD8B-D1FF-430A-B017-A8341EE09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5D8E4B-BD90-480C-8A88-E978D1D82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9746E2-C2BB-42C8-834A-11462861F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E270D5-5B3B-4FA7-A404-356C9FCCD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394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407281-E7E1-445C-BA8F-AB694EAB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0136F6-9D5E-4F13-A637-7E570CB91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A06D24-AAEB-4509-A0D1-2E46D919D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159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CABF2-BE0C-4340-B065-88AC00FA7E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8F90D3-659B-4ED0-B674-EB4C1D4823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3D9B4F-AB20-4A1C-944F-A9707674AB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D260A1-F72D-4A0F-AC4D-E8D788495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B6A27C-AACA-42E5-BBCF-F4272E4A3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DE6713-6C30-4156-984D-1C8BFC04F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333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AED14-8A1B-4B36-BC5A-34625984B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866C91-C984-4890-BE58-C258D2DEB0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6A433A-D34F-4598-97B6-A0E170D9D3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D9A880-AF31-4F7E-8B3D-0F1547747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FFE9A-2B2E-4D09-9EDA-9864072F9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C8C1F5-EF3C-486A-910B-F1BA01EF3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6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4E12B5-0D89-473A-A342-A23AD27257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DC9594-3F00-4E71-B246-71C130542A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0275C8-E411-4C4A-967C-DB3FF52EBA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64063D-E2A0-4484-8877-B4D6F260AB1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B96BB8-34C6-47AE-9810-2928EEAC9B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E86FF1-9D56-4E0A-A18D-1F1DE7F703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28334D-194C-486F-8774-D465FA7B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681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0A6513B-7843-400B-81BC-86E4F8F2D1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1649673"/>
              </p:ext>
            </p:extLst>
          </p:nvPr>
        </p:nvGraphicFramePr>
        <p:xfrm>
          <a:off x="3270063" y="102171"/>
          <a:ext cx="5915230" cy="6653657"/>
        </p:xfrm>
        <a:graphic>
          <a:graphicData uri="http://schemas.openxmlformats.org/drawingml/2006/table">
            <a:tbl>
              <a:tblPr firstRow="1" firstCol="1" bandRow="1"/>
              <a:tblGrid>
                <a:gridCol w="1183046">
                  <a:extLst>
                    <a:ext uri="{9D8B030D-6E8A-4147-A177-3AD203B41FA5}">
                      <a16:colId xmlns:a16="http://schemas.microsoft.com/office/drawing/2014/main" val="2883520059"/>
                    </a:ext>
                  </a:extLst>
                </a:gridCol>
                <a:gridCol w="1183046">
                  <a:extLst>
                    <a:ext uri="{9D8B030D-6E8A-4147-A177-3AD203B41FA5}">
                      <a16:colId xmlns:a16="http://schemas.microsoft.com/office/drawing/2014/main" val="2574593055"/>
                    </a:ext>
                  </a:extLst>
                </a:gridCol>
                <a:gridCol w="1183046">
                  <a:extLst>
                    <a:ext uri="{9D8B030D-6E8A-4147-A177-3AD203B41FA5}">
                      <a16:colId xmlns:a16="http://schemas.microsoft.com/office/drawing/2014/main" val="789170749"/>
                    </a:ext>
                  </a:extLst>
                </a:gridCol>
                <a:gridCol w="1183046">
                  <a:extLst>
                    <a:ext uri="{9D8B030D-6E8A-4147-A177-3AD203B41FA5}">
                      <a16:colId xmlns:a16="http://schemas.microsoft.com/office/drawing/2014/main" val="3283488993"/>
                    </a:ext>
                  </a:extLst>
                </a:gridCol>
                <a:gridCol w="1183046">
                  <a:extLst>
                    <a:ext uri="{9D8B030D-6E8A-4147-A177-3AD203B41FA5}">
                      <a16:colId xmlns:a16="http://schemas.microsoft.com/office/drawing/2014/main" val="1164586374"/>
                    </a:ext>
                  </a:extLst>
                </a:gridCol>
              </a:tblGrid>
              <a:tr h="2006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ate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mple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eographic coordinates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epth 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mpling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7691702"/>
                  </a:ext>
                </a:extLst>
              </a:tr>
              <a:tr h="1071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b="1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[m]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2612065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6990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047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667379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699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0477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2973246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2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09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0278235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2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099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191097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734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648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037263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734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648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2585337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1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840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45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105377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1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840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45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924916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868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86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5110579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868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86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1936486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768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730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6622643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768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730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055568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1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48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29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8904390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1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48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29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346626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1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25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74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273741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2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25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74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1116472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55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23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3677001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6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2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55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23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216638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1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07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05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2215955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2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07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505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594112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6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026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309647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2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6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026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9784082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3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161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913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971985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3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161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913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25365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843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646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3080855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843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646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7166918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18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839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3812200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18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839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5770128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13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83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031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8013928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1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83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031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895351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7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3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008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7292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6650856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1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756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482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2046821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2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756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482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602922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2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591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257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952532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2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591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2574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4771079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3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81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513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0638209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3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9819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513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7909484"/>
                  </a:ext>
                </a:extLst>
              </a:tr>
              <a:tr h="1035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46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187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736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,5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546294"/>
                  </a:ext>
                </a:extLst>
              </a:tr>
              <a:tr h="10716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8.11.2018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47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9187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10.6736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000" dirty="0">
                          <a:solidFill>
                            <a:srgbClr val="000000"/>
                          </a:solidFill>
                          <a:effectLst/>
                          <a:latin typeface="CMR1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,5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4" marR="2500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45909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35318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08</Words>
  <Application>Microsoft Office PowerPoint</Application>
  <PresentationFormat>Widescreen</PresentationFormat>
  <Paragraphs>2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MR10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riana Krolicka</dc:creator>
  <cp:lastModifiedBy>Adriana Krolicka</cp:lastModifiedBy>
  <cp:revision>2</cp:revision>
  <dcterms:created xsi:type="dcterms:W3CDTF">2022-07-22T13:05:14Z</dcterms:created>
  <dcterms:modified xsi:type="dcterms:W3CDTF">2022-07-22T13:08:33Z</dcterms:modified>
</cp:coreProperties>
</file>